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handoutMasterIdLst>
    <p:handoutMasterId r:id="rId6"/>
  </p:handoutMasterIdLst>
  <p:sldIdLst>
    <p:sldId id="259" r:id="rId2"/>
    <p:sldId id="256" r:id="rId3"/>
    <p:sldId id="257" r:id="rId4"/>
    <p:sldId id="258" r:id="rId5"/>
  </p:sldIdLst>
  <p:sldSz cx="12192000" cy="6858000"/>
  <p:notesSz cx="6888163" cy="100187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雄介 國本" userId="37588d4f08e98cf0" providerId="LiveId" clId="{2C62EC69-DC5C-7A4A-8534-0EBDC1AAB6E2}"/>
    <pc:docChg chg="modSld">
      <pc:chgData name="雄介 國本" userId="37588d4f08e98cf0" providerId="LiveId" clId="{2C62EC69-DC5C-7A4A-8534-0EBDC1AAB6E2}" dt="2023-10-14T05:59:23.800" v="3" actId="207"/>
      <pc:docMkLst>
        <pc:docMk/>
      </pc:docMkLst>
      <pc:sldChg chg="modSp mod">
        <pc:chgData name="雄介 國本" userId="37588d4f08e98cf0" providerId="LiveId" clId="{2C62EC69-DC5C-7A4A-8534-0EBDC1AAB6E2}" dt="2023-10-14T05:59:15.362" v="1" actId="207"/>
        <pc:sldMkLst>
          <pc:docMk/>
          <pc:sldMk cId="3926203204" sldId="256"/>
        </pc:sldMkLst>
        <pc:spChg chg="mod">
          <ac:chgData name="雄介 國本" userId="37588d4f08e98cf0" providerId="LiveId" clId="{2C62EC69-DC5C-7A4A-8534-0EBDC1AAB6E2}" dt="2023-10-14T05:59:15.362" v="1" actId="207"/>
          <ac:spMkLst>
            <pc:docMk/>
            <pc:sldMk cId="3926203204" sldId="256"/>
            <ac:spMk id="5" creationId="{B7AB92E2-6FD0-C393-7D70-626222D91517}"/>
          </ac:spMkLst>
        </pc:spChg>
      </pc:sldChg>
      <pc:sldChg chg="modSp mod">
        <pc:chgData name="雄介 國本" userId="37588d4f08e98cf0" providerId="LiveId" clId="{2C62EC69-DC5C-7A4A-8534-0EBDC1AAB6E2}" dt="2023-10-14T05:59:19.453" v="2" actId="207"/>
        <pc:sldMkLst>
          <pc:docMk/>
          <pc:sldMk cId="999893435" sldId="257"/>
        </pc:sldMkLst>
        <pc:spChg chg="mod">
          <ac:chgData name="雄介 國本" userId="37588d4f08e98cf0" providerId="LiveId" clId="{2C62EC69-DC5C-7A4A-8534-0EBDC1AAB6E2}" dt="2023-10-14T05:59:19.453" v="2" actId="207"/>
          <ac:spMkLst>
            <pc:docMk/>
            <pc:sldMk cId="999893435" sldId="257"/>
            <ac:spMk id="7" creationId="{4B879993-DBB6-7CD6-ADF8-4C9622AE6AB9}"/>
          </ac:spMkLst>
        </pc:spChg>
      </pc:sldChg>
      <pc:sldChg chg="modSp mod">
        <pc:chgData name="雄介 國本" userId="37588d4f08e98cf0" providerId="LiveId" clId="{2C62EC69-DC5C-7A4A-8534-0EBDC1AAB6E2}" dt="2023-10-14T05:59:23.800" v="3" actId="207"/>
        <pc:sldMkLst>
          <pc:docMk/>
          <pc:sldMk cId="3845728628" sldId="258"/>
        </pc:sldMkLst>
        <pc:spChg chg="mod">
          <ac:chgData name="雄介 國本" userId="37588d4f08e98cf0" providerId="LiveId" clId="{2C62EC69-DC5C-7A4A-8534-0EBDC1AAB6E2}" dt="2023-10-14T05:59:23.800" v="3" actId="207"/>
          <ac:spMkLst>
            <pc:docMk/>
            <pc:sldMk cId="3845728628" sldId="258"/>
            <ac:spMk id="11" creationId="{82D172F6-249A-CCD5-8F79-4144D2D26A4F}"/>
          </ac:spMkLst>
        </pc:spChg>
      </pc:sldChg>
      <pc:sldChg chg="modSp mod">
        <pc:chgData name="雄介 國本" userId="37588d4f08e98cf0" providerId="LiveId" clId="{2C62EC69-DC5C-7A4A-8534-0EBDC1AAB6E2}" dt="2023-10-14T05:59:06.928" v="0" actId="207"/>
        <pc:sldMkLst>
          <pc:docMk/>
          <pc:sldMk cId="2855120906" sldId="259"/>
        </pc:sldMkLst>
        <pc:spChg chg="mod">
          <ac:chgData name="雄介 國本" userId="37588d4f08e98cf0" providerId="LiveId" clId="{2C62EC69-DC5C-7A4A-8534-0EBDC1AAB6E2}" dt="2023-10-14T05:59:06.928" v="0" actId="207"/>
          <ac:spMkLst>
            <pc:docMk/>
            <pc:sldMk cId="2855120906" sldId="259"/>
            <ac:spMk id="7" creationId="{23192283-E590-C670-A118-29D63007C0E1}"/>
          </ac:spMkLst>
        </pc:spChg>
      </pc:sldChg>
    </pc:docChg>
  </pc:docChgLst>
  <pc:docChgLst>
    <pc:chgData name="雄介 國本" userId="37588d4f08e98cf0" providerId="LiveId" clId="{3A566F50-D016-3449-A457-FFD00ACB2B92}"/>
    <pc:docChg chg="custSel addSld modSld">
      <pc:chgData name="雄介 國本" userId="37588d4f08e98cf0" providerId="LiveId" clId="{3A566F50-D016-3449-A457-FFD00ACB2B92}" dt="2023-06-18T22:24:11.311" v="90" actId="1076"/>
      <pc:docMkLst>
        <pc:docMk/>
      </pc:docMkLst>
      <pc:sldChg chg="modSp mod">
        <pc:chgData name="雄介 國本" userId="37588d4f08e98cf0" providerId="LiveId" clId="{3A566F50-D016-3449-A457-FFD00ACB2B92}" dt="2023-06-18T08:16:28.644" v="51" actId="207"/>
        <pc:sldMkLst>
          <pc:docMk/>
          <pc:sldMk cId="3926203204" sldId="256"/>
        </pc:sldMkLst>
        <pc:spChg chg="mod">
          <ac:chgData name="雄介 國本" userId="37588d4f08e98cf0" providerId="LiveId" clId="{3A566F50-D016-3449-A457-FFD00ACB2B92}" dt="2023-06-18T08:16:28.644" v="51" actId="207"/>
          <ac:spMkLst>
            <pc:docMk/>
            <pc:sldMk cId="3926203204" sldId="256"/>
            <ac:spMk id="5" creationId="{B7AB92E2-6FD0-C393-7D70-626222D91517}"/>
          </ac:spMkLst>
        </pc:spChg>
      </pc:sldChg>
      <pc:sldChg chg="modSp mod">
        <pc:chgData name="雄介 國本" userId="37588d4f08e98cf0" providerId="LiveId" clId="{3A566F50-D016-3449-A457-FFD00ACB2B92}" dt="2023-06-18T08:16:36.956" v="54" actId="207"/>
        <pc:sldMkLst>
          <pc:docMk/>
          <pc:sldMk cId="999893435" sldId="257"/>
        </pc:sldMkLst>
        <pc:spChg chg="mod">
          <ac:chgData name="雄介 國本" userId="37588d4f08e98cf0" providerId="LiveId" clId="{3A566F50-D016-3449-A457-FFD00ACB2B92}" dt="2023-06-18T08:16:36.956" v="54" actId="207"/>
          <ac:spMkLst>
            <pc:docMk/>
            <pc:sldMk cId="999893435" sldId="257"/>
            <ac:spMk id="7" creationId="{4B879993-DBB6-7CD6-ADF8-4C9622AE6AB9}"/>
          </ac:spMkLst>
        </pc:spChg>
      </pc:sldChg>
      <pc:sldChg chg="modSp mod">
        <pc:chgData name="雄介 國本" userId="37588d4f08e98cf0" providerId="LiveId" clId="{3A566F50-D016-3449-A457-FFD00ACB2B92}" dt="2023-06-18T08:16:44.363" v="57" actId="207"/>
        <pc:sldMkLst>
          <pc:docMk/>
          <pc:sldMk cId="3845728628" sldId="258"/>
        </pc:sldMkLst>
        <pc:spChg chg="mod">
          <ac:chgData name="雄介 國本" userId="37588d4f08e98cf0" providerId="LiveId" clId="{3A566F50-D016-3449-A457-FFD00ACB2B92}" dt="2023-06-18T08:16:44.363" v="57" actId="207"/>
          <ac:spMkLst>
            <pc:docMk/>
            <pc:sldMk cId="3845728628" sldId="258"/>
            <ac:spMk id="11" creationId="{82D172F6-249A-CCD5-8F79-4144D2D26A4F}"/>
          </ac:spMkLst>
        </pc:spChg>
      </pc:sldChg>
      <pc:sldChg chg="addSp delSp modSp new mod">
        <pc:chgData name="雄介 國本" userId="37588d4f08e98cf0" providerId="LiveId" clId="{3A566F50-D016-3449-A457-FFD00ACB2B92}" dt="2023-06-18T22:24:11.311" v="90" actId="1076"/>
        <pc:sldMkLst>
          <pc:docMk/>
          <pc:sldMk cId="2855120906" sldId="259"/>
        </pc:sldMkLst>
        <pc:spChg chg="del">
          <ac:chgData name="雄介 國本" userId="37588d4f08e98cf0" providerId="LiveId" clId="{3A566F50-D016-3449-A457-FFD00ACB2B92}" dt="2023-06-18T07:15:16.699" v="1" actId="478"/>
          <ac:spMkLst>
            <pc:docMk/>
            <pc:sldMk cId="2855120906" sldId="259"/>
            <ac:spMk id="2" creationId="{AF3C83B4-1C97-9C12-3219-756A525982CE}"/>
          </ac:spMkLst>
        </pc:spChg>
        <pc:spChg chg="del">
          <ac:chgData name="雄介 國本" userId="37588d4f08e98cf0" providerId="LiveId" clId="{3A566F50-D016-3449-A457-FFD00ACB2B92}" dt="2023-06-18T07:15:18.621" v="2" actId="478"/>
          <ac:spMkLst>
            <pc:docMk/>
            <pc:sldMk cId="2855120906" sldId="259"/>
            <ac:spMk id="3" creationId="{808E13C5-2BEF-E435-C12D-0C703EE43B7E}"/>
          </ac:spMkLst>
        </pc:spChg>
        <pc:spChg chg="add mod">
          <ac:chgData name="雄介 國本" userId="37588d4f08e98cf0" providerId="LiveId" clId="{3A566F50-D016-3449-A457-FFD00ACB2B92}" dt="2023-06-18T08:22:37.595" v="58" actId="207"/>
          <ac:spMkLst>
            <pc:docMk/>
            <pc:sldMk cId="2855120906" sldId="259"/>
            <ac:spMk id="7" creationId="{23192283-E590-C670-A118-29D63007C0E1}"/>
          </ac:spMkLst>
        </pc:spChg>
        <pc:spChg chg="add mod">
          <ac:chgData name="雄介 國本" userId="37588d4f08e98cf0" providerId="LiveId" clId="{3A566F50-D016-3449-A457-FFD00ACB2B92}" dt="2023-06-18T22:21:54.331" v="87" actId="14100"/>
          <ac:spMkLst>
            <pc:docMk/>
            <pc:sldMk cId="2855120906" sldId="259"/>
            <ac:spMk id="9" creationId="{6946625C-53AC-9798-ED64-4DC903A83720}"/>
          </ac:spMkLst>
        </pc:spChg>
        <pc:picChg chg="add del mod">
          <ac:chgData name="雄介 國本" userId="37588d4f08e98cf0" providerId="LiveId" clId="{3A566F50-D016-3449-A457-FFD00ACB2B92}" dt="2023-06-18T22:23:58.611" v="88" actId="478"/>
          <ac:picMkLst>
            <pc:docMk/>
            <pc:sldMk cId="2855120906" sldId="259"/>
            <ac:picMk id="2" creationId="{F14AF110-1CCA-CA07-5782-5A6F0B3CB909}"/>
          </ac:picMkLst>
        </pc:picChg>
        <pc:picChg chg="add mod">
          <ac:chgData name="雄介 國本" userId="37588d4f08e98cf0" providerId="LiveId" clId="{3A566F50-D016-3449-A457-FFD00ACB2B92}" dt="2023-06-18T22:24:11.311" v="90" actId="1076"/>
          <ac:picMkLst>
            <pc:docMk/>
            <pc:sldMk cId="2855120906" sldId="259"/>
            <ac:picMk id="3" creationId="{DBB121A2-93B5-E9B1-9B26-449BED6AF769}"/>
          </ac:picMkLst>
        </pc:picChg>
        <pc:picChg chg="add del mod">
          <ac:chgData name="雄介 國本" userId="37588d4f08e98cf0" providerId="LiveId" clId="{3A566F50-D016-3449-A457-FFD00ACB2B92}" dt="2023-06-18T07:15:45.077" v="4"/>
          <ac:picMkLst>
            <pc:docMk/>
            <pc:sldMk cId="2855120906" sldId="259"/>
            <ac:picMk id="4" creationId="{E29FBCB7-B86C-D191-5CD9-CFD730FA9BE1}"/>
          </ac:picMkLst>
        </pc:picChg>
        <pc:picChg chg="add del mod">
          <ac:chgData name="雄介 國本" userId="37588d4f08e98cf0" providerId="LiveId" clId="{3A566F50-D016-3449-A457-FFD00ACB2B92}" dt="2023-06-18T07:19:29.508" v="7" actId="478"/>
          <ac:picMkLst>
            <pc:docMk/>
            <pc:sldMk cId="2855120906" sldId="259"/>
            <ac:picMk id="5" creationId="{B7115CB9-33BD-D338-9081-B3E77586907A}"/>
          </ac:picMkLst>
        </pc:picChg>
        <pc:picChg chg="add del mod">
          <ac:chgData name="雄介 國本" userId="37588d4f08e98cf0" providerId="LiveId" clId="{3A566F50-D016-3449-A457-FFD00ACB2B92}" dt="2023-06-18T07:36:22.319" v="13" actId="478"/>
          <ac:picMkLst>
            <pc:docMk/>
            <pc:sldMk cId="2855120906" sldId="259"/>
            <ac:picMk id="6" creationId="{744417F4-D8F4-739A-7862-7042D6105C8E}"/>
          </ac:picMkLst>
        </pc:picChg>
        <pc:picChg chg="add del mod">
          <ac:chgData name="雄介 國本" userId="37588d4f08e98cf0" providerId="LiveId" clId="{3A566F50-D016-3449-A457-FFD00ACB2B92}" dt="2023-06-18T22:20:15.659" v="60" actId="478"/>
          <ac:picMkLst>
            <pc:docMk/>
            <pc:sldMk cId="2855120906" sldId="259"/>
            <ac:picMk id="8" creationId="{598215A0-6BF7-10E6-EBC5-883D1AA437ED}"/>
          </ac:picMkLst>
        </pc:pic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901698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r">
              <a:defRPr sz="1300"/>
            </a:lvl1pPr>
          </a:lstStyle>
          <a:p>
            <a:fld id="{F5A321C5-C4BA-4A94-9DC9-35677E814F77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901698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r">
              <a:defRPr sz="1300"/>
            </a:lvl1pPr>
          </a:lstStyle>
          <a:p>
            <a:fld id="{57CEA408-8AF2-48EF-9516-28DAAF4DD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448832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60AB5C-43E5-75BF-3E60-D91A75C4EA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C5CB0BE-D7CB-17B7-B881-B005A83945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3FFDFBF-7EA2-C238-B6F3-05D096EF17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E3303-6614-B048-B657-66C8CB56A018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CEA71A-0CF3-E2C5-EEBA-4A1DD900B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2FAB4B-9AFA-3EBB-BFF0-9401E23256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102F8-A0DA-0D4C-A5D0-D1FA0F2D2B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0484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F126D9A-AC2A-4164-2179-98B8F9B92C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B6FC9E3-44E9-BBBC-BDFB-29A57A7FCC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5C7FF9-57B4-F23E-C8DC-7EBAB7D94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E3303-6614-B048-B657-66C8CB56A018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4997AD0-153F-EFFE-06BA-0B2276E17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6251C6-D234-3DAE-3F31-57CCF524F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102F8-A0DA-0D4C-A5D0-D1FA0F2D2B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2941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A19B61F-6449-08E4-07F0-B9C3417A12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6A39643-22BE-9B74-0E47-B473D26857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0CA117A-A0C7-F25F-4BF7-1AEEAD23B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E3303-6614-B048-B657-66C8CB56A018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F8A75F1-37B0-6601-0CDE-1A8E08913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9E41FD-DD5E-07AB-3B1E-7D8F7CFB9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102F8-A0DA-0D4C-A5D0-D1FA0F2D2B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2336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BD7056-BA45-50B6-BD05-B82B03BC05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837AF73-0FA3-742B-10F4-1AF6D8D4CD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B8A4C9-866C-3C3E-0BFF-A9BC9ADC2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E3303-6614-B048-B657-66C8CB56A018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50E5DAB-9E5B-72A5-88B9-E57D07992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5416B2-D625-01E9-4E2D-CF3275817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102F8-A0DA-0D4C-A5D0-D1FA0F2D2B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7249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50EB47-821A-0300-261B-83A56202DD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B8660C0-9238-76D9-1824-46CF42DAFE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EE6027-6A21-2A1A-EAE4-A258A2572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E3303-6614-B048-B657-66C8CB56A018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38877BE-8850-7BDD-496B-433D1A484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690891A-3262-E236-F159-06D02FA4A2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102F8-A0DA-0D4C-A5D0-D1FA0F2D2B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779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5AD795-BB8D-8244-1C0E-E5EA46CEED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7B25155-F592-DF58-1758-F014A856EC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DAFF157-9EB7-5110-6FE0-17B43B5BD8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B059302-5896-6F59-F591-C147B1FD3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E3303-6614-B048-B657-66C8CB56A018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0E75913-78DD-786B-BC33-D5568C196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4FBA252-DC29-9E47-2E4D-88775D380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102F8-A0DA-0D4C-A5D0-D1FA0F2D2B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7113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693706-D504-1134-4D1D-AC7741E42E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E3DF23-076F-4DBC-5197-18DEA3412D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DE7FFDC-4E30-6427-9CB5-72F92C7E6E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62B34AC-BE5E-B4BF-2F92-F713A7CEC6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4904FDC-F4F7-2781-5435-C2F9B407DC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3163978-0151-0B05-78F5-06197B6868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E3303-6614-B048-B657-66C8CB56A018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9AC2B5F-28EB-3D35-7973-B3A2253841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CB709FD-EF03-2690-8101-BEC1C76B5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102F8-A0DA-0D4C-A5D0-D1FA0F2D2B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4566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242FEA3-3147-0C08-CF71-A692F41377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C2B743A-21DF-43F1-82B9-FBEB3E37BE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E3303-6614-B048-B657-66C8CB56A018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8A092E2-C75B-D691-4644-0CD5088F7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AEB922E-4D9D-2FE4-0DA1-9E689920E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102F8-A0DA-0D4C-A5D0-D1FA0F2D2B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6856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23764BE-E906-82A1-89FF-2AD6140A38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E3303-6614-B048-B657-66C8CB56A018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0B84780-C059-CAA9-1817-34F40A1B2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5977146-11A0-7621-0598-F56F3A447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102F8-A0DA-0D4C-A5D0-D1FA0F2D2B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1260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87E78E-C4B4-9876-3F2F-1F9F13AB5E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5AF0D7D-60EA-3A99-8E73-E9D1380285A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A686B95-4804-1146-E69A-BE7CEC81C1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5F4F19D-654C-EF1F-7D96-25AC0DD20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E3303-6614-B048-B657-66C8CB56A018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5D7FB1F-45C9-9717-CC41-49EC101D02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3733D49-E11C-5951-903D-C7D702A9C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102F8-A0DA-0D4C-A5D0-D1FA0F2D2B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6530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E53C51-A681-D229-0F1E-7D8BCA7A83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A830D85-6B54-1600-6BD7-7395055B85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6B396DB-9CD1-3068-672D-216E084A04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9CC2140-5E43-2833-F62A-F82E560D2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4E3303-6614-B048-B657-66C8CB56A018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B007FD5-0BC1-0993-1809-5D2419C1C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66654C8-9D7F-E3E4-1AFF-AD11FFD20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102F8-A0DA-0D4C-A5D0-D1FA0F2D2B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1076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4ECC1F3-039C-B318-83DA-C5A08B9537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0FF1818-AE19-A539-2C0A-F779362DB2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168AE6-8211-0BA5-C3EE-66AF86D0AE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E3303-6614-B048-B657-66C8CB56A018}" type="datetimeFigureOut">
              <a:rPr kumimoji="1" lang="ja-JP" altLang="en-US" smtClean="0"/>
              <a:t>2023/10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F826919-61B5-B60F-F0B4-956D49A036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4E59522-4B04-A241-47A9-03C221D25A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102F8-A0DA-0D4C-A5D0-D1FA0F2D2B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0457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3192283-E590-C670-A118-29D63007C0E1}"/>
              </a:ext>
            </a:extLst>
          </p:cNvPr>
          <p:cNvSpPr txBox="1"/>
          <p:nvPr/>
        </p:nvSpPr>
        <p:spPr>
          <a:xfrm>
            <a:off x="614855" y="238002"/>
            <a:ext cx="109622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Figure S1	Subject Enrollment Flowchart.</a:t>
            </a:r>
            <a:endParaRPr lang="ja-JP" altLang="ja-JP" sz="1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946625C-53AC-9798-ED64-4DC903A83720}"/>
              </a:ext>
            </a:extLst>
          </p:cNvPr>
          <p:cNvSpPr txBox="1"/>
          <p:nvPr/>
        </p:nvSpPr>
        <p:spPr>
          <a:xfrm>
            <a:off x="1630086" y="6314045"/>
            <a:ext cx="893182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ne patient who did not undergo follow-up BMD measurements was excluded from the BMD changes analysis. 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DBB121A2-93B5-E9B1-9B26-449BED6AF7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798" y="784135"/>
            <a:ext cx="7772400" cy="48062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51209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7AB92E2-6FD0-C393-7D70-626222D91517}"/>
              </a:ext>
            </a:extLst>
          </p:cNvPr>
          <p:cNvSpPr txBox="1"/>
          <p:nvPr/>
        </p:nvSpPr>
        <p:spPr>
          <a:xfrm>
            <a:off x="614855" y="386283"/>
            <a:ext cx="109622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Figure S2	Kaplan–Meier survival curve for denosumab treatment adherence and persistence.</a:t>
            </a:r>
            <a:endParaRPr lang="ja-JP" altLang="ja-JP" sz="18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6" name="図 5" descr="グラフ, 箱ひげ図&#10;&#10;自動的に生成された説明">
            <a:extLst>
              <a:ext uri="{FF2B5EF4-FFF2-40B4-BE49-F238E27FC236}">
                <a16:creationId xmlns:a16="http://schemas.microsoft.com/office/drawing/2014/main" id="{A79465EA-7747-CDA5-568C-7726BA6ECE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083" y="1162689"/>
            <a:ext cx="5392947" cy="3752824"/>
          </a:xfrm>
          <a:prstGeom prst="rect">
            <a:avLst/>
          </a:prstGeom>
        </p:spPr>
      </p:pic>
      <p:pic>
        <p:nvPicPr>
          <p:cNvPr id="7" name="図 6" descr="グラフ, 箱ひげ図&#10;&#10;自動的に生成された説明">
            <a:extLst>
              <a:ext uri="{FF2B5EF4-FFF2-40B4-BE49-F238E27FC236}">
                <a16:creationId xmlns:a16="http://schemas.microsoft.com/office/drawing/2014/main" id="{73AFBCE9-11A3-8F9F-D933-AC9739961D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16600" y="1162689"/>
            <a:ext cx="5392947" cy="3752824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006BF90-B96B-35EE-5E02-C40BCFD688C8}"/>
              </a:ext>
            </a:extLst>
          </p:cNvPr>
          <p:cNvSpPr txBox="1"/>
          <p:nvPr/>
        </p:nvSpPr>
        <p:spPr>
          <a:xfrm>
            <a:off x="1013449" y="916284"/>
            <a:ext cx="473710" cy="34099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</a:t>
            </a:r>
            <a:endParaRPr lang="ja-JP" sz="1400" kern="10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11">
            <a:extLst>
              <a:ext uri="{FF2B5EF4-FFF2-40B4-BE49-F238E27FC236}">
                <a16:creationId xmlns:a16="http://schemas.microsoft.com/office/drawing/2014/main" id="{E7041A79-AEEB-CD2B-7AA9-BF6E397E92D9}"/>
              </a:ext>
            </a:extLst>
          </p:cNvPr>
          <p:cNvSpPr txBox="1"/>
          <p:nvPr/>
        </p:nvSpPr>
        <p:spPr>
          <a:xfrm>
            <a:off x="6531804" y="925213"/>
            <a:ext cx="473710" cy="34099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</a:t>
            </a:r>
            <a:r>
              <a:rPr 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</a:t>
            </a:r>
            <a:endParaRPr lang="ja-JP" sz="1400" kern="10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2CC57A8-4701-2E76-531B-4E6C92170B74}"/>
              </a:ext>
            </a:extLst>
          </p:cNvPr>
          <p:cNvSpPr txBox="1"/>
          <p:nvPr/>
        </p:nvSpPr>
        <p:spPr>
          <a:xfrm>
            <a:off x="756741" y="5295791"/>
            <a:ext cx="1055238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aplan–Meier survival curves for denosumab treatment (A) adherence (n=29; events, n=24; censored, n=5) and (B) persistence (n=29; events, n=16; censored, n=13). The median Kaplan–Meier estimates of the time from the initiation of denosumab treatment to non-adherence and non-persistence were 957 (95% CI, 404–1296)</a:t>
            </a:r>
            <a:r>
              <a:rPr lang="ja-JP" altLang="en-US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ays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</a:t>
            </a:r>
            <a:r>
              <a:rPr lang="en-US" altLang="ja-JP" sz="1400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366 (95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% CI, </a:t>
            </a:r>
            <a:r>
              <a:rPr lang="en-US" altLang="ja-JP" sz="1400" kern="10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992–2973) days,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espectively.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62032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FFF89588-033D-CE40-96B9-DFE8367EA2D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32783" b="2979"/>
          <a:stretch/>
        </p:blipFill>
        <p:spPr bwMode="auto">
          <a:xfrm>
            <a:off x="809007" y="1016583"/>
            <a:ext cx="4714463" cy="420773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3BB92B4E-FDED-D096-E760-5751F6B97E7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595" b="3211"/>
          <a:stretch/>
        </p:blipFill>
        <p:spPr bwMode="auto">
          <a:xfrm>
            <a:off x="6281352" y="1016583"/>
            <a:ext cx="4714463" cy="424806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B879993-DBB6-7CD6-ADF8-4C9622AE6AB9}"/>
              </a:ext>
            </a:extLst>
          </p:cNvPr>
          <p:cNvSpPr txBox="1"/>
          <p:nvPr/>
        </p:nvSpPr>
        <p:spPr>
          <a:xfrm>
            <a:off x="570473" y="264311"/>
            <a:ext cx="1141131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l Figure S3	Comparison of annualized lumbar spine and femoral neck BMD changes between 				denosumab treatment adherence group and non-adherence group at 24 months (n=28).</a:t>
            </a:r>
            <a:r>
              <a:rPr lang="ja-JP" altLang="ja-JP" dirty="0">
                <a:effectLst/>
              </a:rPr>
              <a:t> </a:t>
            </a:r>
            <a:endParaRPr lang="ja-JP" altLang="en-US" dirty="0"/>
          </a:p>
        </p:txBody>
      </p:sp>
      <p:sp>
        <p:nvSpPr>
          <p:cNvPr id="8" name="テキスト ボックス 10">
            <a:extLst>
              <a:ext uri="{FF2B5EF4-FFF2-40B4-BE49-F238E27FC236}">
                <a16:creationId xmlns:a16="http://schemas.microsoft.com/office/drawing/2014/main" id="{D1582359-F70A-9EBD-1334-7696F790CADD}"/>
              </a:ext>
            </a:extLst>
          </p:cNvPr>
          <p:cNvSpPr txBox="1"/>
          <p:nvPr/>
        </p:nvSpPr>
        <p:spPr>
          <a:xfrm>
            <a:off x="2881432" y="1226411"/>
            <a:ext cx="965353" cy="45720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=0.829</a:t>
            </a:r>
            <a:endParaRPr 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13">
            <a:extLst>
              <a:ext uri="{FF2B5EF4-FFF2-40B4-BE49-F238E27FC236}">
                <a16:creationId xmlns:a16="http://schemas.microsoft.com/office/drawing/2014/main" id="{8B48CD17-6305-FC7B-434A-A4819C78378B}"/>
              </a:ext>
            </a:extLst>
          </p:cNvPr>
          <p:cNvSpPr txBox="1"/>
          <p:nvPr/>
        </p:nvSpPr>
        <p:spPr>
          <a:xfrm>
            <a:off x="8346810" y="1228119"/>
            <a:ext cx="944333" cy="45720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=0.089</a:t>
            </a:r>
            <a:endParaRPr 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9838E9D-1A39-75F9-A5A0-84790F3D84A1}"/>
              </a:ext>
            </a:extLst>
          </p:cNvPr>
          <p:cNvSpPr txBox="1"/>
          <p:nvPr/>
        </p:nvSpPr>
        <p:spPr>
          <a:xfrm>
            <a:off x="956441" y="5653154"/>
            <a:ext cx="10468304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ox and whisker plots show the median and interquartile ranges, as well as the upper and lower extremes. A diamond-shaped dot show outlier. We used the Mann–Whitney U test to compare annualized lumbar spine and femoral neck BMD change of denosumab treatment adherence at 24 months. A p-value less than 0.05 indicated statistical significant. 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98934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7A2D5EAE-5B54-CF6B-6F1F-5E1107F9EB54}"/>
              </a:ext>
            </a:extLst>
          </p:cNvPr>
          <p:cNvGrpSpPr/>
          <p:nvPr/>
        </p:nvGrpSpPr>
        <p:grpSpPr>
          <a:xfrm>
            <a:off x="1491911" y="1629201"/>
            <a:ext cx="4003040" cy="3263265"/>
            <a:chOff x="0" y="0"/>
            <a:chExt cx="4003040" cy="3263265"/>
          </a:xfrm>
        </p:grpSpPr>
        <p:pic>
          <p:nvPicPr>
            <p:cNvPr id="5" name="図 4" descr="グラフ, 散布図&#10;&#10;自動的に生成された説明">
              <a:extLst>
                <a:ext uri="{FF2B5EF4-FFF2-40B4-BE49-F238E27FC236}">
                  <a16:creationId xmlns:a16="http://schemas.microsoft.com/office/drawing/2014/main" id="{53C5AEE0-C15F-7A21-00AA-EDA813A78E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1875"/>
            <a:stretch/>
          </p:blipFill>
          <p:spPr bwMode="auto">
            <a:xfrm>
              <a:off x="0" y="0"/>
              <a:ext cx="4003040" cy="3263265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6" name="テキスト ボックス 6">
              <a:extLst>
                <a:ext uri="{FF2B5EF4-FFF2-40B4-BE49-F238E27FC236}">
                  <a16:creationId xmlns:a16="http://schemas.microsoft.com/office/drawing/2014/main" id="{DD131357-2FC7-9DB6-3F63-B5B21C0B012E}"/>
                </a:ext>
              </a:extLst>
            </p:cNvPr>
            <p:cNvSpPr txBox="1"/>
            <p:nvPr/>
          </p:nvSpPr>
          <p:spPr>
            <a:xfrm>
              <a:off x="515565" y="243191"/>
              <a:ext cx="1429966" cy="369651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/>
              <a:r>
                <a:rPr lang="en-US" sz="9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r=</a:t>
              </a:r>
              <a:r>
                <a:rPr lang="ja-JP" sz="9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−</a:t>
              </a:r>
              <a:r>
                <a:rPr lang="en-US" sz="9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0.247, p=0.206</a:t>
              </a:r>
              <a:endParaRPr lang="ja-JP" sz="1050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715E44FD-B4D5-E2B4-2F45-05D444D976B7}"/>
              </a:ext>
            </a:extLst>
          </p:cNvPr>
          <p:cNvGrpSpPr>
            <a:grpSpLocks noChangeAspect="1"/>
          </p:cNvGrpSpPr>
          <p:nvPr/>
        </p:nvGrpSpPr>
        <p:grpSpPr>
          <a:xfrm>
            <a:off x="6189104" y="1629201"/>
            <a:ext cx="3995420" cy="3331845"/>
            <a:chOff x="0" y="0"/>
            <a:chExt cx="3901440" cy="3253740"/>
          </a:xfrm>
        </p:grpSpPr>
        <p:pic>
          <p:nvPicPr>
            <p:cNvPr id="8" name="図 7" descr="グラフ, 散布図&#10;&#10;自動的に生成された説明">
              <a:extLst>
                <a:ext uri="{FF2B5EF4-FFF2-40B4-BE49-F238E27FC236}">
                  <a16:creationId xmlns:a16="http://schemas.microsoft.com/office/drawing/2014/main" id="{8EFB1A7F-DDAE-E9CF-4940-E55B2F8EA7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735"/>
            <a:stretch/>
          </p:blipFill>
          <p:spPr bwMode="auto">
            <a:xfrm>
              <a:off x="0" y="0"/>
              <a:ext cx="3901440" cy="325374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9" name="テキスト ボックス 4">
              <a:extLst>
                <a:ext uri="{FF2B5EF4-FFF2-40B4-BE49-F238E27FC236}">
                  <a16:creationId xmlns:a16="http://schemas.microsoft.com/office/drawing/2014/main" id="{ACA9928D-303D-F147-221C-729BEBE6C185}"/>
                </a:ext>
              </a:extLst>
            </p:cNvPr>
            <p:cNvSpPr txBox="1"/>
            <p:nvPr/>
          </p:nvSpPr>
          <p:spPr>
            <a:xfrm>
              <a:off x="523875" y="257175"/>
              <a:ext cx="1429966" cy="369651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just"/>
              <a:r>
                <a:rPr lang="en-US" sz="9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r=0.173, </a:t>
              </a:r>
              <a:r>
                <a:rPr lang="en-US" sz="900" kern="100" dirty="0">
                  <a:latin typeface="Arial" panose="020B0604020202020204" pitchFamily="34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p</a:t>
              </a:r>
              <a:r>
                <a:rPr lang="en-US" sz="9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Times New Roman" panose="02020603050405020304" pitchFamily="18" charset="0"/>
                </a:rPr>
                <a:t>=0.379</a:t>
              </a:r>
              <a:endParaRPr lang="ja-JP" sz="1050" kern="100" dirty="0">
                <a:effectLst/>
                <a:latin typeface="游明朝" panose="02020400000000000000" pitchFamily="18" charset="-128"/>
                <a:ea typeface="游明朝" panose="02020400000000000000" pitchFamily="18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2D172F6-249A-CCD5-8F79-4144D2D26A4F}"/>
              </a:ext>
            </a:extLst>
          </p:cNvPr>
          <p:cNvSpPr txBox="1"/>
          <p:nvPr/>
        </p:nvSpPr>
        <p:spPr>
          <a:xfrm>
            <a:off x="714703" y="573604"/>
            <a:ext cx="1076259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Figure S4	Correlations between annualized lumbar spine and femoral neck BMD changes 			and medication coverage ratio to follow-up (n=28).</a:t>
            </a:r>
            <a:endParaRPr lang="ja-JP" altLang="ja-JP" sz="1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B7B8D40-FDFD-ED5E-9B5F-82F09F8D42D2}"/>
              </a:ext>
            </a:extLst>
          </p:cNvPr>
          <p:cNvSpPr txBox="1"/>
          <p:nvPr/>
        </p:nvSpPr>
        <p:spPr>
          <a:xfrm>
            <a:off x="1491911" y="5521202"/>
            <a:ext cx="8938347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medication coverage ratio to follow-up was not significantly correlated with the annualized lumbar spine BMD change (r=</a:t>
            </a:r>
            <a:r>
              <a:rPr lang="en-US" altLang="ja-JP" sz="1400" kern="100" dirty="0">
                <a:solidFill>
                  <a:srgbClr val="212121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−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0.247, p=0.206), and femoral neck BMD change (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0.173, 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=0.379).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57286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</TotalTime>
  <Words>326</Words>
  <Application>Microsoft Macintosh PowerPoint</Application>
  <PresentationFormat>ワイド画面</PresentationFormat>
  <Paragraphs>1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國本 雄介</dc:creator>
  <cp:lastModifiedBy>國本 雄介</cp:lastModifiedBy>
  <cp:revision>6</cp:revision>
  <cp:lastPrinted>2023-06-23T10:13:22Z</cp:lastPrinted>
  <dcterms:created xsi:type="dcterms:W3CDTF">2023-04-26T12:29:12Z</dcterms:created>
  <dcterms:modified xsi:type="dcterms:W3CDTF">2023-10-14T05:59:27Z</dcterms:modified>
</cp:coreProperties>
</file>